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4" d="100"/>
          <a:sy n="74" d="100"/>
        </p:scale>
        <p:origin x="936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7B5AB-115C-4E61-A0E7-3FBCA31C07EB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E952B-C8DA-44E7-847F-F7F704729BD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38465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7B5AB-115C-4E61-A0E7-3FBCA31C07EB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E952B-C8DA-44E7-847F-F7F704729BD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66630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7B5AB-115C-4E61-A0E7-3FBCA31C07EB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E952B-C8DA-44E7-847F-F7F704729BD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20535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7B5AB-115C-4E61-A0E7-3FBCA31C07EB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E952B-C8DA-44E7-847F-F7F704729BD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6735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7B5AB-115C-4E61-A0E7-3FBCA31C07EB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E952B-C8DA-44E7-847F-F7F704729BD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52396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7B5AB-115C-4E61-A0E7-3FBCA31C07EB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E952B-C8DA-44E7-847F-F7F704729BD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14526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7B5AB-115C-4E61-A0E7-3FBCA31C07EB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E952B-C8DA-44E7-847F-F7F704729BD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98926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7B5AB-115C-4E61-A0E7-3FBCA31C07EB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E952B-C8DA-44E7-847F-F7F704729BD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72351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7B5AB-115C-4E61-A0E7-3FBCA31C07EB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E952B-C8DA-44E7-847F-F7F704729BD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43566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7B5AB-115C-4E61-A0E7-3FBCA31C07EB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E952B-C8DA-44E7-847F-F7F704729BD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79587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7B5AB-115C-4E61-A0E7-3FBCA31C07EB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E952B-C8DA-44E7-847F-F7F704729BD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81397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47B5AB-115C-4E61-A0E7-3FBCA31C07EB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8E952B-C8DA-44E7-847F-F7F704729BD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77873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 rotWithShape="1">
          <a:blip r:embed="rId2"/>
          <a:srcRect l="1523" t="843" r="559" b="843"/>
          <a:stretch/>
        </p:blipFill>
        <p:spPr>
          <a:xfrm>
            <a:off x="550476" y="930155"/>
            <a:ext cx="3893026" cy="2841745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 rotWithShape="1">
          <a:blip r:embed="rId3"/>
          <a:srcRect l="903" t="2264" r="971" b="1695"/>
          <a:stretch/>
        </p:blipFill>
        <p:spPr>
          <a:xfrm>
            <a:off x="5393054" y="696190"/>
            <a:ext cx="4117937" cy="2930237"/>
          </a:xfrm>
          <a:prstGeom prst="rect">
            <a:avLst/>
          </a:prstGeom>
        </p:spPr>
      </p:pic>
      <p:sp>
        <p:nvSpPr>
          <p:cNvPr id="2" name="CuadroTexto 1"/>
          <p:cNvSpPr txBox="1"/>
          <p:nvPr/>
        </p:nvSpPr>
        <p:spPr>
          <a:xfrm>
            <a:off x="270162" y="249381"/>
            <a:ext cx="106402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err="1" smtClean="0"/>
              <a:t>Supplementary</a:t>
            </a:r>
            <a:r>
              <a:rPr lang="es-ES" b="1" dirty="0" smtClean="0"/>
              <a:t> Material S3</a:t>
            </a:r>
            <a:r>
              <a:rPr lang="es-ES" dirty="0" smtClean="0"/>
              <a:t> </a:t>
            </a:r>
            <a:r>
              <a:rPr lang="en-US" dirty="0" err="1"/>
              <a:t>Hypoglycaemia</a:t>
            </a:r>
            <a:r>
              <a:rPr lang="en-US" dirty="0"/>
              <a:t> metrics and association with physical activity</a:t>
            </a:r>
            <a:endParaRPr lang="en-GB" dirty="0"/>
          </a:p>
        </p:txBody>
      </p:sp>
      <p:pic>
        <p:nvPicPr>
          <p:cNvPr id="6" name="Imagen 5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0476" y="3771900"/>
            <a:ext cx="4094260" cy="2862363"/>
          </a:xfrm>
          <a:prstGeom prst="rect">
            <a:avLst/>
          </a:prstGeom>
          <a:noFill/>
        </p:spPr>
      </p:pic>
      <p:pic>
        <p:nvPicPr>
          <p:cNvPr id="7" name="Imagen 6"/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3622" y="3703903"/>
            <a:ext cx="4027369" cy="2863151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41737417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a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24671640"/>
              </p:ext>
            </p:extLst>
          </p:nvPr>
        </p:nvGraphicFramePr>
        <p:xfrm>
          <a:off x="227879" y="865908"/>
          <a:ext cx="5356225" cy="3049591"/>
        </p:xfrm>
        <a:graphic>
          <a:graphicData uri="http://schemas.openxmlformats.org/drawingml/2006/table">
            <a:tbl>
              <a:tblPr firstRow="1" firstCol="1" bandRow="1"/>
              <a:tblGrid>
                <a:gridCol w="1005840">
                  <a:extLst>
                    <a:ext uri="{9D8B030D-6E8A-4147-A177-3AD203B41FA5}">
                      <a16:colId xmlns:a16="http://schemas.microsoft.com/office/drawing/2014/main" val="384801588"/>
                    </a:ext>
                  </a:extLst>
                </a:gridCol>
                <a:gridCol w="952500">
                  <a:extLst>
                    <a:ext uri="{9D8B030D-6E8A-4147-A177-3AD203B41FA5}">
                      <a16:colId xmlns:a16="http://schemas.microsoft.com/office/drawing/2014/main" val="3475112451"/>
                    </a:ext>
                  </a:extLst>
                </a:gridCol>
                <a:gridCol w="2879725">
                  <a:extLst>
                    <a:ext uri="{9D8B030D-6E8A-4147-A177-3AD203B41FA5}">
                      <a16:colId xmlns:a16="http://schemas.microsoft.com/office/drawing/2014/main" val="3518050243"/>
                    </a:ext>
                  </a:extLst>
                </a:gridCol>
                <a:gridCol w="518160">
                  <a:extLst>
                    <a:ext uri="{9D8B030D-6E8A-4147-A177-3AD203B41FA5}">
                      <a16:colId xmlns:a16="http://schemas.microsoft.com/office/drawing/2014/main" val="148059341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del (TBR &lt; 70 mg/dL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erm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β (95% CI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393175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del 1</a:t>
                      </a:r>
                      <a:b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N=334; R²=0.0157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MI (kg/m²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−0.0210 (−0.0429, 0.0009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6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544121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−0.00115 (−0.00727, 0.00496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1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395872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x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−0.1246 (−0.3216, 0.0723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1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42610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del 2</a:t>
                      </a:r>
                      <a:b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N=332; R²=0.0105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MI (kg/m²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−0.0194 (−0.0412, 0.00233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8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576952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et incom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.58e−06 (−1.05e−05, 1.97e−05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5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774789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del 3</a:t>
                      </a:r>
                      <a:br>
                        <a:rPr lang="en-US" sz="1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N=332; R²=0.0181)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MI (kg/m²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288 (−0.0346, 0.0923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7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408215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et incom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.89e−05 (−1.42e−05, 1.72e−04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9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13177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MI × Net income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−2.93e−06 (−6.55e−06, 6.90e−07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12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105661"/>
                  </a:ext>
                </a:extLst>
              </a:tr>
            </a:tbl>
          </a:graphicData>
        </a:graphic>
      </p:graphicFrame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227879" y="191753"/>
            <a:ext cx="5518294" cy="6001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. Association between BMI, socioeconomic status (net income), and </a:t>
            </a:r>
            <a:r>
              <a:rPr kumimoji="0" lang="en-US" altLang="en-US" sz="11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ypoglycaemia</a:t>
            </a:r>
            <a:r>
              <a:rPr kumimoji="0" lang="en-US" alt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kumimoji="0" lang="en-GB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utcome: natural logarithm of time below range &lt;70 mg/</a:t>
            </a:r>
            <a:r>
              <a:rPr kumimoji="0" lang="en-US" altLang="en-US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L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Coefficients are beta estimates from linear regression with 95% confidence intervals.</a:t>
            </a:r>
            <a:endParaRPr kumimoji="0" lang="en-GB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" name="Rectángulo 5"/>
          <p:cNvSpPr/>
          <p:nvPr/>
        </p:nvSpPr>
        <p:spPr>
          <a:xfrm>
            <a:off x="123970" y="3989490"/>
            <a:ext cx="5622203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breviations: BMI, body mass index; CI, confidence interval ;TBR&lt;70 mg/</a:t>
            </a:r>
            <a:r>
              <a:rPr lang="en-US" alt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L</a:t>
            </a:r>
            <a:r>
              <a:rPr lang="en-US" alt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log-transformed time below range &lt;70 mg/</a:t>
            </a:r>
            <a:r>
              <a:rPr lang="en-US" alt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L</a:t>
            </a:r>
            <a:endParaRPr lang="en-US" altLang="en-US" dirty="0">
              <a:latin typeface="Arial" panose="020B0604020202020204" pitchFamily="34" charset="0"/>
            </a:endParaRPr>
          </a:p>
        </p:txBody>
      </p:sp>
      <p:graphicFrame>
        <p:nvGraphicFramePr>
          <p:cNvPr id="7" name="Tabla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7134033"/>
              </p:ext>
            </p:extLst>
          </p:nvPr>
        </p:nvGraphicFramePr>
        <p:xfrm>
          <a:off x="6403619" y="865908"/>
          <a:ext cx="5441235" cy="2690814"/>
        </p:xfrm>
        <a:graphic>
          <a:graphicData uri="http://schemas.openxmlformats.org/drawingml/2006/table">
            <a:tbl>
              <a:tblPr firstRow="1" firstCol="1" bandRow="1"/>
              <a:tblGrid>
                <a:gridCol w="1088247">
                  <a:extLst>
                    <a:ext uri="{9D8B030D-6E8A-4147-A177-3AD203B41FA5}">
                      <a16:colId xmlns:a16="http://schemas.microsoft.com/office/drawing/2014/main" val="2518557895"/>
                    </a:ext>
                  </a:extLst>
                </a:gridCol>
                <a:gridCol w="1088247">
                  <a:extLst>
                    <a:ext uri="{9D8B030D-6E8A-4147-A177-3AD203B41FA5}">
                      <a16:colId xmlns:a16="http://schemas.microsoft.com/office/drawing/2014/main" val="1323132463"/>
                    </a:ext>
                  </a:extLst>
                </a:gridCol>
                <a:gridCol w="1088247">
                  <a:extLst>
                    <a:ext uri="{9D8B030D-6E8A-4147-A177-3AD203B41FA5}">
                      <a16:colId xmlns:a16="http://schemas.microsoft.com/office/drawing/2014/main" val="1763913403"/>
                    </a:ext>
                  </a:extLst>
                </a:gridCol>
                <a:gridCol w="1096622">
                  <a:extLst>
                    <a:ext uri="{9D8B030D-6E8A-4147-A177-3AD203B41FA5}">
                      <a16:colId xmlns:a16="http://schemas.microsoft.com/office/drawing/2014/main" val="736535209"/>
                    </a:ext>
                  </a:extLst>
                </a:gridCol>
                <a:gridCol w="1079872">
                  <a:extLst>
                    <a:ext uri="{9D8B030D-6E8A-4147-A177-3AD203B41FA5}">
                      <a16:colId xmlns:a16="http://schemas.microsoft.com/office/drawing/2014/main" val="289578866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variat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β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5% CI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odel info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16038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ge (years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0.01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0.017 to -0.00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0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341; R²=0.05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2733223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ex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0.07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0.279 to 0.13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47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58987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ETs quartile 2 vs 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14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0.136 to 0.42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31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37750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ETs quartile 3 vs 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12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0.160 to 0.41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38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031389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ETs quartile 4 vs 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33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41 to 0.62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2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992358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et incom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28e-06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1.31e-05 to 1.97e-0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69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92147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iabetes duration (years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1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06 to 0.02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981563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MI (kg/m²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0.00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0.032 to 0.01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41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0189206"/>
                  </a:ext>
                </a:extLst>
              </a:tr>
            </a:tbl>
          </a:graphicData>
        </a:graphic>
      </p:graphicFrame>
      <p:sp>
        <p:nvSpPr>
          <p:cNvPr id="8" name="Rectangle 2"/>
          <p:cNvSpPr>
            <a:spLocks noChangeArrowheads="1"/>
          </p:cNvSpPr>
          <p:nvPr/>
        </p:nvSpPr>
        <p:spPr bwMode="auto">
          <a:xfrm>
            <a:off x="6299709" y="244078"/>
            <a:ext cx="4427815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ultivariable linear regression for number of </a:t>
            </a:r>
            <a:r>
              <a:rPr kumimoji="0" lang="en-US" altLang="en-US" sz="11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ypoglycaemic</a:t>
            </a:r>
            <a:r>
              <a:rPr kumimoji="0" lang="en-US" alt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pisodes 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9" name="Tabla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52961771"/>
              </p:ext>
            </p:extLst>
          </p:nvPr>
        </p:nvGraphicFramePr>
        <p:xfrm>
          <a:off x="6403619" y="4051501"/>
          <a:ext cx="5441235" cy="2690814"/>
        </p:xfrm>
        <a:graphic>
          <a:graphicData uri="http://schemas.openxmlformats.org/drawingml/2006/table">
            <a:tbl>
              <a:tblPr firstRow="1" firstCol="1" bandRow="1"/>
              <a:tblGrid>
                <a:gridCol w="1128449">
                  <a:extLst>
                    <a:ext uri="{9D8B030D-6E8A-4147-A177-3AD203B41FA5}">
                      <a16:colId xmlns:a16="http://schemas.microsoft.com/office/drawing/2014/main" val="3584432588"/>
                    </a:ext>
                  </a:extLst>
                </a:gridCol>
                <a:gridCol w="1071546">
                  <a:extLst>
                    <a:ext uri="{9D8B030D-6E8A-4147-A177-3AD203B41FA5}">
                      <a16:colId xmlns:a16="http://schemas.microsoft.com/office/drawing/2014/main" val="3664604636"/>
                    </a:ext>
                  </a:extLst>
                </a:gridCol>
                <a:gridCol w="1071546">
                  <a:extLst>
                    <a:ext uri="{9D8B030D-6E8A-4147-A177-3AD203B41FA5}">
                      <a16:colId xmlns:a16="http://schemas.microsoft.com/office/drawing/2014/main" val="3706157918"/>
                    </a:ext>
                  </a:extLst>
                </a:gridCol>
                <a:gridCol w="1141776">
                  <a:extLst>
                    <a:ext uri="{9D8B030D-6E8A-4147-A177-3AD203B41FA5}">
                      <a16:colId xmlns:a16="http://schemas.microsoft.com/office/drawing/2014/main" val="151059668"/>
                    </a:ext>
                  </a:extLst>
                </a:gridCol>
                <a:gridCol w="1027918">
                  <a:extLst>
                    <a:ext uri="{9D8B030D-6E8A-4147-A177-3AD203B41FA5}">
                      <a16:colId xmlns:a16="http://schemas.microsoft.com/office/drawing/2014/main" val="291143796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variat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β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5% CI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odel info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914424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ge (years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0.004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0.0085 to -0.000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2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340; R²=0.04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69814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ex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0.04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0.158 to 0.06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40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666091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ETs quartile 2 vs 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2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0.123 to 0.18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71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938233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ETs quartile 3 vs 1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0.08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0.243 to 0.06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27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070708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ETs quartile 4 vs 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0.01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0.172 to 0.14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85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32425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et incom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55e-06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6.34e-06 to 1.14e-0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57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886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iabetes duration (years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07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026 to 0.011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0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17452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MI (kg/m²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0.005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0.018 to 0.006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36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3303009"/>
                  </a:ext>
                </a:extLst>
              </a:tr>
            </a:tbl>
          </a:graphicData>
        </a:graphic>
      </p:graphicFrame>
      <p:sp>
        <p:nvSpPr>
          <p:cNvPr id="10" name="Rectangle 3"/>
          <p:cNvSpPr>
            <a:spLocks noChangeArrowheads="1"/>
          </p:cNvSpPr>
          <p:nvPr/>
        </p:nvSpPr>
        <p:spPr bwMode="auto">
          <a:xfrm>
            <a:off x="6299709" y="3620614"/>
            <a:ext cx="3946914" cy="430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ultivariable linear regression for duration of </a:t>
            </a:r>
            <a:r>
              <a:rPr kumimoji="0" lang="en-US" altLang="en-US" sz="11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ypoglycaemia</a:t>
            </a:r>
            <a:r>
              <a:rPr kumimoji="0" lang="en-US" alt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0" lang="en-GB" altLang="en-US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2218934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406</Words>
  <Application>Microsoft Office PowerPoint</Application>
  <PresentationFormat>Panorámica</PresentationFormat>
  <Paragraphs>132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e Office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ernando</dc:creator>
  <cp:lastModifiedBy>Fernando</cp:lastModifiedBy>
  <cp:revision>9</cp:revision>
  <dcterms:created xsi:type="dcterms:W3CDTF">2025-07-22T12:11:36Z</dcterms:created>
  <dcterms:modified xsi:type="dcterms:W3CDTF">2026-02-20T10:47:52Z</dcterms:modified>
</cp:coreProperties>
</file>